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58" r:id="rId2"/>
  </p:sldIdLst>
  <p:sldSz cx="12960350" cy="21959888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68" autoAdjust="0"/>
    <p:restoredTop sz="94660"/>
  </p:normalViewPr>
  <p:slideViewPr>
    <p:cSldViewPr snapToGrid="0">
      <p:cViewPr>
        <p:scale>
          <a:sx n="48" d="100"/>
          <a:sy n="48" d="100"/>
        </p:scale>
        <p:origin x="-1542" y="-78"/>
      </p:cViewPr>
      <p:guideLst>
        <p:guide orient="horz" pos="6916"/>
        <p:guide pos="40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0865300D-C0DB-4A38-BD44-A77EA31991B3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674C055D-3DDC-4A69-8032-9333AC9DD4D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5991568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8CBEB62A-5263-4422-9935-2F8A43E720BE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447925" y="1252538"/>
            <a:ext cx="1993900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4" tIns="48317" rIns="96634" bIns="48317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3034"/>
            <a:ext cx="5511800" cy="3946118"/>
          </a:xfrm>
          <a:prstGeom prst="rect">
            <a:avLst/>
          </a:prstGeom>
        </p:spPr>
        <p:txBody>
          <a:bodyPr vert="horz" lIns="96634" tIns="48317" rIns="96634" bIns="48317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D3554FBB-5347-4C5F-BB9D-09F70482850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20570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83796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67593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251389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335186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418982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502779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586575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670372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026" y="3593900"/>
            <a:ext cx="11016298" cy="7645294"/>
          </a:xfrm>
        </p:spPr>
        <p:txBody>
          <a:bodyPr anchor="b"/>
          <a:lstStyle>
            <a:lvl1pPr algn="ctr"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045" y="11534026"/>
            <a:ext cx="9720263" cy="5301888"/>
          </a:xfrm>
        </p:spPr>
        <p:txBody>
          <a:bodyPr/>
          <a:lstStyle>
            <a:lvl1pPr marL="0" indent="0" algn="ctr">
              <a:buNone/>
              <a:defRPr sz="3402"/>
            </a:lvl1pPr>
            <a:lvl2pPr marL="648004" indent="0" algn="ctr">
              <a:buNone/>
              <a:defRPr sz="2835"/>
            </a:lvl2pPr>
            <a:lvl3pPr marL="1296008" indent="0" algn="ctr">
              <a:buNone/>
              <a:defRPr sz="2551"/>
            </a:lvl3pPr>
            <a:lvl4pPr marL="1944013" indent="0" algn="ctr">
              <a:buNone/>
              <a:defRPr sz="2268"/>
            </a:lvl4pPr>
            <a:lvl5pPr marL="2592017" indent="0" algn="ctr">
              <a:buNone/>
              <a:defRPr sz="2268"/>
            </a:lvl5pPr>
            <a:lvl6pPr marL="3240020" indent="0" algn="ctr">
              <a:buNone/>
              <a:defRPr sz="2268"/>
            </a:lvl6pPr>
            <a:lvl7pPr marL="3888025" indent="0" algn="ctr">
              <a:buNone/>
              <a:defRPr sz="2268"/>
            </a:lvl7pPr>
            <a:lvl8pPr marL="4536030" indent="0" algn="ctr">
              <a:buNone/>
              <a:defRPr sz="2268"/>
            </a:lvl8pPr>
            <a:lvl9pPr marL="5184033" indent="0" algn="ctr">
              <a:buNone/>
              <a:defRPr sz="2268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3E5F-05D8-4883-BBA5-F544EA65A67D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946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8F2E-E25A-4875-A211-19CDE50E7B66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6345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4753" y="1169161"/>
            <a:ext cx="2794575" cy="1860999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025" y="1169161"/>
            <a:ext cx="8221722" cy="1860999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23612-7092-43E6-87EE-5F3D47EAF4D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75147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0705D-CDE0-4A8B-BD00-0C51EB3C5965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14432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275" y="5474729"/>
            <a:ext cx="11178302" cy="9134702"/>
          </a:xfrm>
        </p:spPr>
        <p:txBody>
          <a:bodyPr anchor="b"/>
          <a:lstStyle>
            <a:lvl1pPr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275" y="14695848"/>
            <a:ext cx="11178302" cy="4803724"/>
          </a:xfrm>
        </p:spPr>
        <p:txBody>
          <a:bodyPr/>
          <a:lstStyle>
            <a:lvl1pPr marL="0" indent="0">
              <a:buNone/>
              <a:defRPr sz="3402">
                <a:solidFill>
                  <a:schemeClr val="tx1"/>
                </a:solidFill>
              </a:defRPr>
            </a:lvl1pPr>
            <a:lvl2pPr marL="64800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08" indent="0">
              <a:buNone/>
              <a:defRPr sz="2551">
                <a:solidFill>
                  <a:schemeClr val="tx1">
                    <a:tint val="75000"/>
                  </a:schemeClr>
                </a:solidFill>
              </a:defRPr>
            </a:lvl3pPr>
            <a:lvl4pPr marL="194401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4pPr>
            <a:lvl5pPr marL="2592017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5pPr>
            <a:lvl6pPr marL="324002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6pPr>
            <a:lvl7pPr marL="3888025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7pPr>
            <a:lvl8pPr marL="453603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8pPr>
            <a:lvl9pPr marL="518403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4F3DD-5303-44B3-94EB-3881814DB7A2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11127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024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179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8C83-F889-49C6-8258-A889429BD78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72481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169166"/>
            <a:ext cx="11178302" cy="4244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715" y="5383224"/>
            <a:ext cx="5482835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715" y="8021460"/>
            <a:ext cx="5482835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180" y="5383224"/>
            <a:ext cx="5509837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180" y="8021460"/>
            <a:ext cx="5509837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85AAA-86E6-4820-B832-9D5BB2BD7504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44109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3C208-5E4C-41D1-9C78-730AEC10AC88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215179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92E73-36E3-4BA5-A847-F77E213AA44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14210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09839" y="3161822"/>
            <a:ext cx="6561177" cy="15605754"/>
          </a:xfrm>
        </p:spPr>
        <p:txBody>
          <a:bodyPr/>
          <a:lstStyle>
            <a:lvl1pPr>
              <a:defRPr sz="4536"/>
            </a:lvl1pPr>
            <a:lvl2pPr>
              <a:defRPr sz="3968"/>
            </a:lvl2pPr>
            <a:lvl3pPr>
              <a:defRPr sz="3402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ED3DE-4B30-48B5-95BB-DF6A3298C28C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107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09839" y="3161822"/>
            <a:ext cx="6561177" cy="15605754"/>
          </a:xfrm>
        </p:spPr>
        <p:txBody>
          <a:bodyPr anchor="t"/>
          <a:lstStyle>
            <a:lvl1pPr marL="0" indent="0">
              <a:buNone/>
              <a:defRPr sz="4536"/>
            </a:lvl1pPr>
            <a:lvl2pPr marL="648004" indent="0">
              <a:buNone/>
              <a:defRPr sz="3968"/>
            </a:lvl2pPr>
            <a:lvl3pPr marL="1296008" indent="0">
              <a:buNone/>
              <a:defRPr sz="3402"/>
            </a:lvl3pPr>
            <a:lvl4pPr marL="1944013" indent="0">
              <a:buNone/>
              <a:defRPr sz="2835"/>
            </a:lvl4pPr>
            <a:lvl5pPr marL="2592017" indent="0">
              <a:buNone/>
              <a:defRPr sz="2835"/>
            </a:lvl5pPr>
            <a:lvl6pPr marL="3240020" indent="0">
              <a:buNone/>
              <a:defRPr sz="2835"/>
            </a:lvl6pPr>
            <a:lvl7pPr marL="3888025" indent="0">
              <a:buNone/>
              <a:defRPr sz="2835"/>
            </a:lvl7pPr>
            <a:lvl8pPr marL="4536030" indent="0">
              <a:buNone/>
              <a:defRPr sz="2835"/>
            </a:lvl8pPr>
            <a:lvl9pPr marL="5184033" indent="0">
              <a:buNone/>
              <a:defRPr sz="2835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E1A72-34A7-4777-9297-BECAC6DDF237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1215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024" y="1169166"/>
            <a:ext cx="11178302" cy="4244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1024" y="5845805"/>
            <a:ext cx="11178302" cy="139333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1026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E6F1D-3C5F-40DC-B246-DD4AB1E6FA63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3116" y="20353569"/>
            <a:ext cx="4374118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3249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1093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1296008" rtl="0" eaLnBrk="1" latinLnBrk="1" hangingPunct="1">
        <a:lnSpc>
          <a:spcPct val="90000"/>
        </a:lnSpc>
        <a:spcBef>
          <a:spcPct val="0"/>
        </a:spcBef>
        <a:buNone/>
        <a:defRPr sz="62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03" indent="-324003" algn="l" defTabSz="1296008" rtl="0" eaLnBrk="1" latinLnBrk="1" hangingPunct="1">
        <a:lnSpc>
          <a:spcPct val="90000"/>
        </a:lnSpc>
        <a:spcBef>
          <a:spcPts val="1418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1pPr>
      <a:lvl2pPr marL="97200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2pPr>
      <a:lvl3pPr marL="162001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014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91602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564023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421202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860032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508036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1pPr>
      <a:lvl2pPr marL="648004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96008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3pPr>
      <a:lvl4pPr marL="194401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592017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24002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3888025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53603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18403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" name="표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443400716"/>
              </p:ext>
            </p:extLst>
          </p:nvPr>
        </p:nvGraphicFramePr>
        <p:xfrm>
          <a:off x="65702" y="1441310"/>
          <a:ext cx="12834549" cy="421907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3522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133066">
                  <a:extLst>
                    <a:ext uri="{9D8B030D-6E8A-4147-A177-3AD203B41FA5}">
                      <a16:colId xmlns:a16="http://schemas.microsoft.com/office/drawing/2014/main" xmlns="" val="1870204054"/>
                    </a:ext>
                  </a:extLst>
                </a:gridCol>
                <a:gridCol w="1019331">
                  <a:extLst>
                    <a:ext uri="{9D8B030D-6E8A-4147-A177-3AD203B41FA5}">
                      <a16:colId xmlns:a16="http://schemas.microsoft.com/office/drawing/2014/main" xmlns="" val="2202965807"/>
                    </a:ext>
                  </a:extLst>
                </a:gridCol>
                <a:gridCol w="1184223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721905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98359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267327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850231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906585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       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f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hildren/</a:t>
                      </a:r>
                    </a:p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olescent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77668976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hi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8 [32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13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9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77; 1.05]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02593090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olli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6 [38] 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9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1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2.14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9844090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ijhof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67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63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14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088713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im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74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8; 1.27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929021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on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79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8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23; 0.49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483619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arme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80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71; 3.32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07206588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alde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3 [81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4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38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91075489"/>
                  </a:ext>
                </a:extLst>
              </a:tr>
              <a:tr h="369205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76; 0.91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287650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ffects 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22; 1.35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7745429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98.9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1.4319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lt;0.01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graphicFrame>
        <p:nvGraphicFramePr>
          <p:cNvPr id="36" name="표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737594110"/>
              </p:ext>
            </p:extLst>
          </p:nvPr>
        </p:nvGraphicFramePr>
        <p:xfrm>
          <a:off x="46705" y="5747278"/>
          <a:ext cx="12834550" cy="361262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3522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331945">
                  <a:extLst>
                    <a:ext uri="{9D8B030D-6E8A-4147-A177-3AD203B41FA5}">
                      <a16:colId xmlns:a16="http://schemas.microsoft.com/office/drawing/2014/main" xmlns="" val="1870204054"/>
                    </a:ext>
                  </a:extLst>
                </a:gridCol>
                <a:gridCol w="869430">
                  <a:extLst>
                    <a:ext uri="{9D8B030D-6E8A-4147-A177-3AD203B41FA5}">
                      <a16:colId xmlns:a16="http://schemas.microsoft.com/office/drawing/2014/main" xmlns="" val="889489863"/>
                    </a:ext>
                  </a:extLst>
                </a:gridCol>
                <a:gridCol w="1259174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597977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98359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267327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850231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906585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       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f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fic population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84603309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H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8 [7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7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5; 1.10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02593090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uiber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78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3.15; 4.16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9844090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cCaule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82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42; 3.58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088713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8 [86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79; 1.50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929021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93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7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41; 1.35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4836199"/>
                  </a:ext>
                </a:extLst>
              </a:tr>
              <a:tr h="369205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.39; 3.04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248271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61; 2.78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7745429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95.0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90000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0.6657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lt;0.01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90000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E6ABCF5D-6227-477D-A84F-866680B7F045}"/>
              </a:ext>
            </a:extLst>
          </p:cNvPr>
          <p:cNvSpPr txBox="1"/>
          <p:nvPr/>
        </p:nvSpPr>
        <p:spPr>
          <a:xfrm>
            <a:off x="65702" y="1003820"/>
            <a:ext cx="117481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-analysis of the CFS/ME prevalence for children and adolescents (A) and specific populations (B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" name="그룹 37"/>
          <p:cNvGrpSpPr/>
          <p:nvPr/>
        </p:nvGrpSpPr>
        <p:grpSpPr>
          <a:xfrm>
            <a:off x="4021337" y="1961035"/>
            <a:ext cx="5723467" cy="3529083"/>
            <a:chOff x="4052681" y="1975103"/>
            <a:chExt cx="5723467" cy="3529083"/>
          </a:xfrm>
        </p:grpSpPr>
        <p:pic>
          <p:nvPicPr>
            <p:cNvPr id="39" name="그림 38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271279" y="1975103"/>
              <a:ext cx="2773199" cy="2880683"/>
            </a:xfrm>
            <a:prstGeom prst="rect">
              <a:avLst/>
            </a:prstGeom>
          </p:spPr>
        </p:pic>
        <p:grpSp>
          <p:nvGrpSpPr>
            <p:cNvPr id="40" name="그룹 39"/>
            <p:cNvGrpSpPr/>
            <p:nvPr/>
          </p:nvGrpSpPr>
          <p:grpSpPr>
            <a:xfrm>
              <a:off x="4052681" y="5053659"/>
              <a:ext cx="5723467" cy="450527"/>
              <a:chOff x="4052681" y="5053659"/>
              <a:chExt cx="5723467" cy="450527"/>
            </a:xfrm>
          </p:grpSpPr>
          <p:sp>
            <p:nvSpPr>
              <p:cNvPr id="41" name="TextBox 40"/>
              <p:cNvSpPr txBox="1"/>
              <p:nvPr/>
            </p:nvSpPr>
            <p:spPr>
              <a:xfrm>
                <a:off x="4052681" y="5185637"/>
                <a:ext cx="5723467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            1.0            2.0           3.0           4.0            5.0            6.0 (%)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2" name="그림 41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4255533" y="5053659"/>
                <a:ext cx="4749402" cy="196996"/>
              </a:xfrm>
              <a:prstGeom prst="rect">
                <a:avLst/>
              </a:prstGeom>
            </p:spPr>
          </p:pic>
        </p:grpSp>
      </p:grpSp>
      <p:grpSp>
        <p:nvGrpSpPr>
          <p:cNvPr id="43" name="그룹 42"/>
          <p:cNvGrpSpPr/>
          <p:nvPr/>
        </p:nvGrpSpPr>
        <p:grpSpPr>
          <a:xfrm>
            <a:off x="4111277" y="6169828"/>
            <a:ext cx="5723467" cy="3167584"/>
            <a:chOff x="4052680" y="6536436"/>
            <a:chExt cx="5723467" cy="2955569"/>
          </a:xfrm>
        </p:grpSpPr>
        <p:pic>
          <p:nvPicPr>
            <p:cNvPr id="44" name="그림 4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417078" y="6536436"/>
              <a:ext cx="3702793" cy="2417411"/>
            </a:xfrm>
            <a:prstGeom prst="rect">
              <a:avLst/>
            </a:prstGeom>
          </p:spPr>
        </p:pic>
        <p:grpSp>
          <p:nvGrpSpPr>
            <p:cNvPr id="45" name="그룹 44"/>
            <p:cNvGrpSpPr/>
            <p:nvPr/>
          </p:nvGrpSpPr>
          <p:grpSpPr>
            <a:xfrm>
              <a:off x="4052680" y="9041478"/>
              <a:ext cx="5723467" cy="450527"/>
              <a:chOff x="4164456" y="9966310"/>
              <a:chExt cx="5723467" cy="450527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4164456" y="10098288"/>
                <a:ext cx="5723467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            1.0            2.0           3.0           4.0            5.0            6.0 (%)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7" name="그림 46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4367308" y="9966310"/>
                <a:ext cx="4749402" cy="196996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xmlns="" val="40172139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0</TotalTime>
  <Words>367</Words>
  <Application>Microsoft Office PowerPoint</Application>
  <PresentationFormat>Custom</PresentationFormat>
  <Paragraphs>20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0016236</cp:lastModifiedBy>
  <cp:revision>21</cp:revision>
  <cp:lastPrinted>2020-01-02T00:55:33Z</cp:lastPrinted>
  <dcterms:created xsi:type="dcterms:W3CDTF">2019-12-30T09:07:39Z</dcterms:created>
  <dcterms:modified xsi:type="dcterms:W3CDTF">2020-02-15T03:25:25Z</dcterms:modified>
</cp:coreProperties>
</file>